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1" d="100"/>
          <a:sy n="51" d="100"/>
        </p:scale>
        <p:origin x="43" y="6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1B8D6E3-7AD8-4425-3F3A-DCF1C01F935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0CAB7F8-323D-D9AD-DC02-BBD2AD493A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077AF86-2F6F-FB8C-5118-7A0C30228C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7C07D-A9B0-45C0-B101-658C7DE287ED}" type="datetimeFigureOut">
              <a:rPr lang="zh-CN" altLang="en-US" smtClean="0"/>
              <a:t>2023/3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CC3E7CD-1C47-847E-439A-E407408F48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E413123-D3BF-634E-B50D-DD3D059A2B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A48D4-B005-4A48-96B5-9013BEA9D8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28363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AFC03D9-72B5-1B50-ADB4-9CAA31CE63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41032AF-1047-A839-8DC6-4392C8339F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A183FB-1FE9-92A4-4217-39B49400E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7C07D-A9B0-45C0-B101-658C7DE287ED}" type="datetimeFigureOut">
              <a:rPr lang="zh-CN" altLang="en-US" smtClean="0"/>
              <a:t>2023/3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499475-B5DF-D43C-63C9-6BBF5BEA9A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F68C7CF-D5B3-7806-3E6A-301343630F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A48D4-B005-4A48-96B5-9013BEA9D8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1051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7BFE38A-DA78-5229-B601-B029D7FB53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35AFC70-7E2B-AA1C-DA9D-62EDEF6962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ECABB33-6286-EA7C-22E1-12680DF5EC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7C07D-A9B0-45C0-B101-658C7DE287ED}" type="datetimeFigureOut">
              <a:rPr lang="zh-CN" altLang="en-US" smtClean="0"/>
              <a:t>2023/3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81F33B0-C524-8F5E-ACDB-EB16AB4460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35042B1-299B-95A6-8A6D-215DD00E9D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A48D4-B005-4A48-96B5-9013BEA9D8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73620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2526B03-9F1D-E9A9-F73B-C49C6266CD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BD092B2-7225-C665-35A2-5D09BAE152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DCD4466-0D04-AD56-2BE1-5C4F4023FD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7C07D-A9B0-45C0-B101-658C7DE287ED}" type="datetimeFigureOut">
              <a:rPr lang="zh-CN" altLang="en-US" smtClean="0"/>
              <a:t>2023/3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E4855A9-3062-F42F-ED70-12E5F399D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6250927-0702-1A4E-A743-B748C772E3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A48D4-B005-4A48-96B5-9013BEA9D8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963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0B177A-5ACE-8341-876F-581D2AE800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CAB469F-091F-D950-90F6-7EB45418B5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DBF6BB0-BD37-5BCF-0A78-57D56135D1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7C07D-A9B0-45C0-B101-658C7DE287ED}" type="datetimeFigureOut">
              <a:rPr lang="zh-CN" altLang="en-US" smtClean="0"/>
              <a:t>2023/3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895812D-1008-EC0E-53D9-D3033FCEA3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3E85CFA-220E-0698-1811-C35D46AFF3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A48D4-B005-4A48-96B5-9013BEA9D8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0061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00DECA8-241A-763D-E3F8-370E455512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654061C-3CF5-4548-1DF9-2C34B48397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1551453-B63D-9F71-EE71-1C8D868CF2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F66FB58-A05B-E61B-8DAE-6CFAB874A5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7C07D-A9B0-45C0-B101-658C7DE287ED}" type="datetimeFigureOut">
              <a:rPr lang="zh-CN" altLang="en-US" smtClean="0"/>
              <a:t>2023/3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41FE181-13A8-09F4-4964-C691A5F086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8847F9F-147C-C2F2-A09E-9C79D271CE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A48D4-B005-4A48-96B5-9013BEA9D8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15994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442DA0-E67D-D2F1-CA90-0545A4837B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70CE466-9D48-50F5-8BF0-F441B09090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14D3C6B-7E38-B74D-C615-82F1356870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74FE2E9-BEB4-D3E2-E35D-29F096E5A8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24CA2E1-7EF2-88E5-CEFF-0BD291472B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7F3EF89-EC86-3F33-F6D1-C856CCA277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7C07D-A9B0-45C0-B101-658C7DE287ED}" type="datetimeFigureOut">
              <a:rPr lang="zh-CN" altLang="en-US" smtClean="0"/>
              <a:t>2023/3/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297F2F7-AFF8-9882-793E-63136BB693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15C0573-655F-7376-5154-D45CE25AF1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A48D4-B005-4A48-96B5-9013BEA9D8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6191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B4C023-1460-999C-FAE5-33CB6745CF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FCBB816-30DC-96CD-9D6E-BC5AD11B9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7C07D-A9B0-45C0-B101-658C7DE287ED}" type="datetimeFigureOut">
              <a:rPr lang="zh-CN" altLang="en-US" smtClean="0"/>
              <a:t>2023/3/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80E5D99-5338-0F7B-0F13-979D83CF66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261233A-40D1-D222-FDB4-61B7F497E6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A48D4-B005-4A48-96B5-9013BEA9D8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92283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F77E9B3-6AC7-8BB9-215B-1DDD3FA0A8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7C07D-A9B0-45C0-B101-658C7DE287ED}" type="datetimeFigureOut">
              <a:rPr lang="zh-CN" altLang="en-US" smtClean="0"/>
              <a:t>2023/3/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6E9E0E9-E186-A56B-E699-68C9445451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6C491EF-D913-4CED-632E-445454AF84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A48D4-B005-4A48-96B5-9013BEA9D8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8328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ECC4F5-4276-4073-7CFC-7C4F86B00E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F49D7EA-4B2E-C806-1F47-2165E857E3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7533471-A62F-A290-A456-F74BFB09CF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37C1742-1C41-D1AF-B5F9-FED5E82F2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7C07D-A9B0-45C0-B101-658C7DE287ED}" type="datetimeFigureOut">
              <a:rPr lang="zh-CN" altLang="en-US" smtClean="0"/>
              <a:t>2023/3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130519A-E094-00BA-82E9-1A50275C37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57959E9-5F6B-7F70-FA72-96D68A948F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A48D4-B005-4A48-96B5-9013BEA9D8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21471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FC1A2C-7AA1-626E-0406-EA2C9CD55D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576A23C-A14A-3E9B-1A35-DADF951161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7AF6B41-2632-B7C1-6E0E-626E12144D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C69B08B-AA7F-B458-F996-8810EB6571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7C07D-A9B0-45C0-B101-658C7DE287ED}" type="datetimeFigureOut">
              <a:rPr lang="zh-CN" altLang="en-US" smtClean="0"/>
              <a:t>2023/3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3216BC5-E8A9-40CF-1B6C-8FFA7DB823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E3DE3AB-8A19-7EA2-2F52-F18AF63B6F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A48D4-B005-4A48-96B5-9013BEA9D8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881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B9795CF-EF3A-FF84-76EE-6C55361288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B6283C3-98F5-9B17-1921-B556DFA8F2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ABA2E9-FD7E-84FB-6EF4-2053A54404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77C07D-A9B0-45C0-B101-658C7DE287ED}" type="datetimeFigureOut">
              <a:rPr lang="zh-CN" altLang="en-US" smtClean="0"/>
              <a:t>2023/3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4AADF0A-68F1-C6B0-04E3-7E32B12E148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1298008-5761-7D2B-69D8-628BA6F7140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4A48D4-B005-4A48-96B5-9013BEA9D8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4314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E0BD4A5-9D2A-6B76-8303-32E92CD2B1A4}"/>
              </a:ext>
            </a:extLst>
          </p:cNvPr>
          <p:cNvSpPr txBox="1"/>
          <p:nvPr/>
        </p:nvSpPr>
        <p:spPr>
          <a:xfrm>
            <a:off x="649357" y="4678017"/>
            <a:ext cx="109833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. Full-length blots/gels </a:t>
            </a:r>
            <a:r>
              <a:rPr lang="en-US" altLang="zh-CN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f intestinal M-CSF and GAPDH protein in HC , UC and UD patients. HC: healthy control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zh-CN" altLang="en-US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UC:</a:t>
            </a:r>
            <a:r>
              <a:rPr lang="zh-CN" altLang="en-US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ulcerative colitis,</a:t>
            </a:r>
            <a:r>
              <a:rPr lang="zh-CN" altLang="en-US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UD:</a:t>
            </a:r>
            <a:r>
              <a:rPr lang="zh-CN" altLang="en-US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UC patients with symptoms of anxiety/depression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DA4943FE-331A-4382-EC43-67D19A77421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46" t="32240" r="7232" b="39801"/>
          <a:stretch/>
        </p:blipFill>
        <p:spPr bwMode="auto">
          <a:xfrm>
            <a:off x="4234208" y="1272304"/>
            <a:ext cx="3948256" cy="1019739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95861E76-CE01-9B89-DBC1-9FCA653E2D0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6" t="32018" r="11137" b="34136"/>
          <a:stretch/>
        </p:blipFill>
        <p:spPr bwMode="auto">
          <a:xfrm>
            <a:off x="4166648" y="2327952"/>
            <a:ext cx="4185500" cy="122505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228A087B-D249-944C-FDD0-5EA96B81A70B}"/>
              </a:ext>
            </a:extLst>
          </p:cNvPr>
          <p:cNvCxnSpPr/>
          <p:nvPr/>
        </p:nvCxnSpPr>
        <p:spPr>
          <a:xfrm>
            <a:off x="3750117" y="2894672"/>
            <a:ext cx="33936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9C5C2DE4-BDD0-9D08-ADB8-FC3A5E404E06}"/>
              </a:ext>
            </a:extLst>
          </p:cNvPr>
          <p:cNvCxnSpPr>
            <a:cxnSpLocks/>
          </p:cNvCxnSpPr>
          <p:nvPr/>
        </p:nvCxnSpPr>
        <p:spPr>
          <a:xfrm>
            <a:off x="5024488" y="1225166"/>
            <a:ext cx="707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BE06B31C-0B20-00AB-2DDB-5B5EC20AD8CD}"/>
              </a:ext>
            </a:extLst>
          </p:cNvPr>
          <p:cNvCxnSpPr/>
          <p:nvPr/>
        </p:nvCxnSpPr>
        <p:spPr>
          <a:xfrm>
            <a:off x="3750117" y="1963918"/>
            <a:ext cx="33936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95E5B953-FB44-E08C-30BC-AB6F3E5C28DA}"/>
              </a:ext>
            </a:extLst>
          </p:cNvPr>
          <p:cNvCxnSpPr>
            <a:cxnSpLocks/>
          </p:cNvCxnSpPr>
          <p:nvPr/>
        </p:nvCxnSpPr>
        <p:spPr>
          <a:xfrm>
            <a:off x="5844621" y="1225166"/>
            <a:ext cx="707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EB6D7A59-379D-A3F0-09A2-B74EAC61D4FD}"/>
              </a:ext>
            </a:extLst>
          </p:cNvPr>
          <p:cNvCxnSpPr>
            <a:cxnSpLocks/>
          </p:cNvCxnSpPr>
          <p:nvPr/>
        </p:nvCxnSpPr>
        <p:spPr>
          <a:xfrm>
            <a:off x="6685177" y="1225166"/>
            <a:ext cx="707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4C1499BC-FD70-DBC7-FDBA-B370793F1FBB}"/>
              </a:ext>
            </a:extLst>
          </p:cNvPr>
          <p:cNvSpPr txBox="1"/>
          <p:nvPr/>
        </p:nvSpPr>
        <p:spPr>
          <a:xfrm>
            <a:off x="5147038" y="849941"/>
            <a:ext cx="537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AC7B33BB-7E02-2AA8-FF4D-23A1C01AE1BE}"/>
              </a:ext>
            </a:extLst>
          </p:cNvPr>
          <p:cNvSpPr txBox="1"/>
          <p:nvPr/>
        </p:nvSpPr>
        <p:spPr>
          <a:xfrm>
            <a:off x="5929462" y="849941"/>
            <a:ext cx="537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C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DCA47337-53A7-815C-B26A-242555416619}"/>
              </a:ext>
            </a:extLst>
          </p:cNvPr>
          <p:cNvSpPr txBox="1"/>
          <p:nvPr/>
        </p:nvSpPr>
        <p:spPr>
          <a:xfrm>
            <a:off x="6770018" y="852598"/>
            <a:ext cx="537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D</a:t>
            </a: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2258CC36-B879-0FAA-61DE-38CB8AE943F4}"/>
              </a:ext>
            </a:extLst>
          </p:cNvPr>
          <p:cNvSpPr txBox="1"/>
          <p:nvPr/>
        </p:nvSpPr>
        <p:spPr>
          <a:xfrm>
            <a:off x="2841608" y="1671530"/>
            <a:ext cx="9481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</a:p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95152A85-081C-397C-613D-071FB03AE754}"/>
              </a:ext>
            </a:extLst>
          </p:cNvPr>
          <p:cNvSpPr txBox="1"/>
          <p:nvPr/>
        </p:nvSpPr>
        <p:spPr>
          <a:xfrm>
            <a:off x="2849463" y="2602284"/>
            <a:ext cx="9481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</a:p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DC001EC0-ECFC-B4EC-0EEE-408D51BB6DFF}"/>
              </a:ext>
            </a:extLst>
          </p:cNvPr>
          <p:cNvSpPr txBox="1"/>
          <p:nvPr/>
        </p:nvSpPr>
        <p:spPr>
          <a:xfrm>
            <a:off x="2590834" y="1264435"/>
            <a:ext cx="15628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-CSF (60kD)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1D55E809-EBE9-D864-87A1-53B75F062BD4}"/>
              </a:ext>
            </a:extLst>
          </p:cNvPr>
          <p:cNvSpPr txBox="1"/>
          <p:nvPr/>
        </p:nvSpPr>
        <p:spPr>
          <a:xfrm>
            <a:off x="2521699" y="2314418"/>
            <a:ext cx="16320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 (37KD)</a:t>
            </a:r>
          </a:p>
        </p:txBody>
      </p:sp>
    </p:spTree>
    <p:extLst>
      <p:ext uri="{BB962C8B-B14F-4D97-AF65-F5344CB8AC3E}">
        <p14:creationId xmlns:p14="http://schemas.microsoft.com/office/powerpoint/2010/main" val="584372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0</TotalTime>
  <Words>57</Words>
  <Application>Microsoft Office PowerPoint</Application>
  <PresentationFormat>宽屏</PresentationFormat>
  <Paragraphs>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uan Shihao</dc:creator>
  <cp:lastModifiedBy>Duan Shihao</cp:lastModifiedBy>
  <cp:revision>8</cp:revision>
  <dcterms:created xsi:type="dcterms:W3CDTF">2022-08-11T10:02:22Z</dcterms:created>
  <dcterms:modified xsi:type="dcterms:W3CDTF">2023-03-01T14:07:44Z</dcterms:modified>
</cp:coreProperties>
</file>